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1" d="100"/>
          <a:sy n="71" d="100"/>
        </p:scale>
        <p:origin x="-1746" y="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amgid\Desktop\CA15-3%20MGL%20and%20WGA%20in%20PLOS%20One\Supplementary%20data\Supplementary%20data%20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amgid\Desktop\CA15-3%20MGL%20and%20WGA%20in%20PLOS%20One\Supplementary%20data\Supplementary%20data%20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i-FI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 dirty="0" smtClean="0"/>
              <a:t>(A) CA15-3 WGA-NP</a:t>
            </a:r>
            <a:endParaRPr lang="en-US" b="0" dirty="0"/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Results-WGA'!$C$23</c:f>
              <c:strCache>
                <c:ptCount val="1"/>
                <c:pt idx="0">
                  <c:v>WGA-NP TSA-BSA</c:v>
                </c:pt>
              </c:strCache>
            </c:strRef>
          </c:tx>
          <c:spPr>
            <a:ln w="28575">
              <a:noFill/>
            </a:ln>
          </c:spPr>
          <c:trendline>
            <c:trendlineType val="linear"/>
            <c:dispRSqr val="1"/>
            <c:dispEq val="1"/>
            <c:trendlineLbl>
              <c:layout>
                <c:manualLayout>
                  <c:x val="-2.8406638766481425E-2"/>
                  <c:y val="-8.1426137836536679E-3"/>
                </c:manualLayout>
              </c:layout>
              <c:tx>
                <c:rich>
                  <a:bodyPr/>
                  <a:lstStyle/>
                  <a:p>
                    <a:pPr>
                      <a:defRPr sz="1000"/>
                    </a:pPr>
                    <a:r>
                      <a:rPr lang="fi-FI" sz="1100" baseline="0" dirty="0" err="1"/>
                      <a:t>Analytical</a:t>
                    </a:r>
                    <a:r>
                      <a:rPr lang="fi-FI" sz="1100" baseline="0" dirty="0"/>
                      <a:t> </a:t>
                    </a:r>
                    <a:r>
                      <a:rPr lang="fi-FI" sz="1100" baseline="0" dirty="0" err="1"/>
                      <a:t>sensitivity</a:t>
                    </a:r>
                    <a:r>
                      <a:rPr lang="fi-FI" sz="1100" baseline="0" dirty="0"/>
                      <a:t> (</a:t>
                    </a:r>
                    <a:r>
                      <a:rPr lang="fi-FI" sz="1100" baseline="0" dirty="0" err="1"/>
                      <a:t>Background</a:t>
                    </a:r>
                    <a:r>
                      <a:rPr lang="fi-FI" sz="1100" baseline="0" dirty="0"/>
                      <a:t> +3SD)</a:t>
                    </a:r>
                  </a:p>
                  <a:p>
                    <a:pPr>
                      <a:defRPr sz="1000"/>
                    </a:pPr>
                    <a:r>
                      <a:rPr lang="fi-FI" sz="1100" baseline="0" dirty="0"/>
                      <a:t>0.25 U/ml</a:t>
                    </a:r>
                  </a:p>
                  <a:p>
                    <a:pPr>
                      <a:defRPr sz="1000"/>
                    </a:pPr>
                    <a:endParaRPr lang="fi-FI" baseline="0" dirty="0"/>
                  </a:p>
                  <a:p>
                    <a:pPr>
                      <a:defRPr sz="1000"/>
                    </a:pPr>
                    <a:r>
                      <a:rPr lang="fi-FI" baseline="0" dirty="0"/>
                      <a:t>y = 122,24x + 303,96
R² = 0,997</a:t>
                    </a:r>
                    <a:endParaRPr lang="fi-FI" dirty="0"/>
                  </a:p>
                </c:rich>
              </c:tx>
              <c:numFmt formatCode="General" sourceLinked="0"/>
            </c:trendlineLbl>
          </c:trendline>
          <c:xVal>
            <c:numRef>
              <c:f>'Results-WGA'!$B$24:$B$29</c:f>
              <c:numCache>
                <c:formatCode>0</c:formatCode>
                <c:ptCount val="6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50</c:v>
                </c:pt>
                <c:pt idx="4">
                  <c:v>100</c:v>
                </c:pt>
                <c:pt idx="5">
                  <c:v>125</c:v>
                </c:pt>
              </c:numCache>
            </c:numRef>
          </c:xVal>
          <c:yVal>
            <c:numRef>
              <c:f>'Results-WGA'!$C$24:$C$29</c:f>
              <c:numCache>
                <c:formatCode>0</c:formatCode>
                <c:ptCount val="6"/>
                <c:pt idx="0">
                  <c:v>152.58333333333331</c:v>
                </c:pt>
                <c:pt idx="1">
                  <c:v>911.58333333333348</c:v>
                </c:pt>
                <c:pt idx="2">
                  <c:v>1598.9166666666667</c:v>
                </c:pt>
                <c:pt idx="3">
                  <c:v>6585.916666666667</c:v>
                </c:pt>
                <c:pt idx="4">
                  <c:v>13058.916666666666</c:v>
                </c:pt>
                <c:pt idx="5">
                  <c:v>15087.91666666666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58D-4641-A77F-7B73AE5E62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338816"/>
        <c:axId val="32915840"/>
      </c:scatterChart>
      <c:valAx>
        <c:axId val="703388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fi-FI" b="0"/>
                  <a:t>CA15-3 (U/ml)</a:t>
                </a:r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crossAx val="32915840"/>
        <c:crosses val="autoZero"/>
        <c:crossBetween val="midCat"/>
      </c:valAx>
      <c:valAx>
        <c:axId val="3291584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b="0"/>
                </a:pPr>
                <a:r>
                  <a:rPr lang="fi-FI" b="0"/>
                  <a:t>Specific Signals</a:t>
                </a:r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crossAx val="7033881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i-FI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fi-FI" dirty="0" smtClean="0"/>
              <a:t>(B) CA15-3 MGL-NP</a:t>
            </a:r>
            <a:endParaRPr lang="fi-FI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950378322176258"/>
          <c:y val="0.15504084944176033"/>
          <c:w val="0.74674588724003443"/>
          <c:h val="0.65827715602229608"/>
        </c:manualLayout>
      </c:layout>
      <c:scatterChart>
        <c:scatterStyle val="lineMarker"/>
        <c:varyColors val="0"/>
        <c:ser>
          <c:idx val="0"/>
          <c:order val="0"/>
          <c:tx>
            <c:strRef>
              <c:f>'Results-MGLFc'!$L$30</c:f>
              <c:strCache>
                <c:ptCount val="1"/>
                <c:pt idx="0">
                  <c:v>CA15-3 MGL-NP in TSA-BSA</c:v>
                </c:pt>
              </c:strCache>
            </c:strRef>
          </c:tx>
          <c:spPr>
            <a:ln w="28575">
              <a:noFill/>
            </a:ln>
          </c:spPr>
          <c:trendline>
            <c:trendlineType val="linear"/>
            <c:dispRSqr val="1"/>
            <c:dispEq val="1"/>
            <c:trendlineLbl>
              <c:layout>
                <c:manualLayout>
                  <c:x val="6.8403507518398701E-3"/>
                  <c:y val="-4.1685590432144178E-3"/>
                </c:manualLayout>
              </c:layout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fi-FI" sz="1100" b="0" i="0" baseline="0" dirty="0" err="1" smtClean="0">
                        <a:effectLst/>
                      </a:rPr>
                      <a:t>Analytical</a:t>
                    </a:r>
                    <a:r>
                      <a:rPr lang="fi-FI" sz="1100" b="0" i="0" baseline="0" dirty="0" smtClean="0">
                        <a:effectLst/>
                      </a:rPr>
                      <a:t> </a:t>
                    </a:r>
                    <a:r>
                      <a:rPr lang="fi-FI" sz="1100" b="0" i="0" baseline="0" dirty="0" err="1" smtClean="0">
                        <a:effectLst/>
                      </a:rPr>
                      <a:t>sensitivity</a:t>
                    </a:r>
                    <a:r>
                      <a:rPr lang="fi-FI" sz="1100" b="0" i="0" baseline="0" dirty="0" smtClean="0">
                        <a:effectLst/>
                      </a:rPr>
                      <a:t> (</a:t>
                    </a:r>
                    <a:r>
                      <a:rPr lang="fi-FI" sz="1100" b="0" i="0" baseline="0" dirty="0" err="1" smtClean="0">
                        <a:effectLst/>
                      </a:rPr>
                      <a:t>Background</a:t>
                    </a:r>
                    <a:r>
                      <a:rPr lang="fi-FI" sz="1100" b="0" i="0" baseline="0" dirty="0" smtClean="0">
                        <a:effectLst/>
                      </a:rPr>
                      <a:t> +3SD)</a:t>
                    </a:r>
                    <a:endParaRPr lang="fi-FI" sz="1100" dirty="0" smtClean="0">
                      <a:effectLst/>
                    </a:endParaRPr>
                  </a:p>
                  <a:p>
                    <a:pPr>
                      <a:defRPr/>
                    </a:pPr>
                    <a:r>
                      <a:rPr lang="fi-FI" sz="1100" b="0" i="0" baseline="0" dirty="0" smtClean="0">
                        <a:effectLst/>
                      </a:rPr>
                      <a:t>0.23 U/ml</a:t>
                    </a:r>
                  </a:p>
                  <a:p>
                    <a:pPr>
                      <a:defRPr/>
                    </a:pPr>
                    <a:endParaRPr lang="fi-FI" sz="1100" dirty="0" smtClean="0">
                      <a:effectLst/>
                    </a:endParaRPr>
                  </a:p>
                  <a:p>
                    <a:pPr>
                      <a:defRPr/>
                    </a:pPr>
                    <a:r>
                      <a:rPr lang="en-US" baseline="0" dirty="0" smtClean="0"/>
                      <a:t>y </a:t>
                    </a:r>
                    <a:r>
                      <a:rPr lang="en-US" baseline="0" dirty="0"/>
                      <a:t>= 156,57x + 218,09
R² = 0,9961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'Results-MGLFc'!$K$31:$K$36</c:f>
              <c:numCache>
                <c:formatCode>0</c:formatCode>
                <c:ptCount val="6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50</c:v>
                </c:pt>
                <c:pt idx="4">
                  <c:v>100</c:v>
                </c:pt>
                <c:pt idx="5">
                  <c:v>125</c:v>
                </c:pt>
              </c:numCache>
            </c:numRef>
          </c:xVal>
          <c:yVal>
            <c:numRef>
              <c:f>'Results-MGLFc'!$L$31:$L$36</c:f>
              <c:numCache>
                <c:formatCode>0</c:formatCode>
                <c:ptCount val="6"/>
                <c:pt idx="0">
                  <c:v>95.188405797101467</c:v>
                </c:pt>
                <c:pt idx="1">
                  <c:v>862.85507246376801</c:v>
                </c:pt>
                <c:pt idx="2">
                  <c:v>1634.5217391304348</c:v>
                </c:pt>
                <c:pt idx="3">
                  <c:v>9087.5217391304341</c:v>
                </c:pt>
                <c:pt idx="4">
                  <c:v>15489.521739130434</c:v>
                </c:pt>
                <c:pt idx="5">
                  <c:v>19702.18840579710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968-4C11-B438-81F8B96D8B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829952"/>
        <c:axId val="70832128"/>
      </c:scatterChart>
      <c:valAx>
        <c:axId val="708299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fi-FI" b="0"/>
                  <a:t>CA15-3 (U/ml)</a:t>
                </a:r>
              </a:p>
            </c:rich>
          </c:tx>
          <c:layout>
            <c:manualLayout>
              <c:xMode val="edge"/>
              <c:yMode val="edge"/>
              <c:x val="0.48749282407464434"/>
              <c:y val="0.90080112265072432"/>
            </c:manualLayout>
          </c:layout>
          <c:overlay val="0"/>
        </c:title>
        <c:numFmt formatCode="0" sourceLinked="1"/>
        <c:majorTickMark val="out"/>
        <c:minorTickMark val="none"/>
        <c:tickLblPos val="nextTo"/>
        <c:crossAx val="70832128"/>
        <c:crosses val="autoZero"/>
        <c:crossBetween val="midCat"/>
      </c:valAx>
      <c:valAx>
        <c:axId val="708321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b="0"/>
                </a:pPr>
                <a:r>
                  <a:rPr lang="fi-FI" b="0"/>
                  <a:t>Specific Signals</a:t>
                </a:r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crossAx val="7082995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9D46E4-A7E6-4A54-81D6-E1BEC341A606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i-FI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9F85DC-400A-4B8B-AB9B-6529D53FC23D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16065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A9472-8584-4874-84A7-99CF3ADA10ED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891CB-2765-407C-B47C-691AF15FC34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121919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A9472-8584-4874-84A7-99CF3ADA10ED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891CB-2765-407C-B47C-691AF15FC34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788813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A9472-8584-4874-84A7-99CF3ADA10ED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891CB-2765-407C-B47C-691AF15FC34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947965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A9472-8584-4874-84A7-99CF3ADA10ED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891CB-2765-407C-B47C-691AF15FC34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918832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A9472-8584-4874-84A7-99CF3ADA10ED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891CB-2765-407C-B47C-691AF15FC34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89144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A9472-8584-4874-84A7-99CF3ADA10ED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891CB-2765-407C-B47C-691AF15FC34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00235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A9472-8584-4874-84A7-99CF3ADA10ED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891CB-2765-407C-B47C-691AF15FC34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703732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A9472-8584-4874-84A7-99CF3ADA10ED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891CB-2765-407C-B47C-691AF15FC34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68915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A9472-8584-4874-84A7-99CF3ADA10ED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891CB-2765-407C-B47C-691AF15FC34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86746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A9472-8584-4874-84A7-99CF3ADA10ED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891CB-2765-407C-B47C-691AF15FC34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194356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A9472-8584-4874-84A7-99CF3ADA10ED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891CB-2765-407C-B47C-691AF15FC34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1894556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9A9472-8584-4874-84A7-99CF3ADA10ED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891CB-2765-407C-B47C-691AF15FC34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818525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926227" y="4077072"/>
            <a:ext cx="757957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-FI" sz="1400" b="1" dirty="0" smtClean="0"/>
              <a:t>S1 </a:t>
            </a:r>
            <a:r>
              <a:rPr lang="fi-FI" sz="1400" b="1" dirty="0" err="1" smtClean="0"/>
              <a:t>Fig</a:t>
            </a:r>
            <a:r>
              <a:rPr lang="fi-FI" sz="1400" b="1" dirty="0" smtClean="0"/>
              <a:t>. </a:t>
            </a:r>
            <a:r>
              <a:rPr lang="en-US" sz="1400" b="1" dirty="0"/>
              <a:t>Calibration </a:t>
            </a:r>
            <a:r>
              <a:rPr lang="en-US" sz="1400" b="1" dirty="0" smtClean="0"/>
              <a:t>curves of (A) CA15-3 WGA and (B) CA15-3-MGL </a:t>
            </a:r>
            <a:r>
              <a:rPr lang="en-US" sz="1400" b="1" dirty="0"/>
              <a:t>NPs-lectin </a:t>
            </a:r>
            <a:r>
              <a:rPr lang="en-US" sz="1400" b="1" dirty="0" smtClean="0"/>
              <a:t>assay.</a:t>
            </a:r>
            <a:r>
              <a:rPr lang="en-US" sz="1400" dirty="0" smtClean="0"/>
              <a:t> Both are linear in range of 1 to 125 U/ml with excellent analytical sensitivity.</a:t>
            </a:r>
            <a:endParaRPr lang="fi-FI" sz="1400" dirty="0"/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546562"/>
              </p:ext>
            </p:extLst>
          </p:nvPr>
        </p:nvGraphicFramePr>
        <p:xfrm>
          <a:off x="467544" y="692696"/>
          <a:ext cx="4015505" cy="324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4575007"/>
              </p:ext>
            </p:extLst>
          </p:nvPr>
        </p:nvGraphicFramePr>
        <p:xfrm>
          <a:off x="4716016" y="620688"/>
          <a:ext cx="4058710" cy="32829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017414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15</TotalTime>
  <Words>56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Turk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lesh Gidwani</dc:creator>
  <cp:lastModifiedBy>Kamlesh Gidwani</cp:lastModifiedBy>
  <cp:revision>49</cp:revision>
  <dcterms:created xsi:type="dcterms:W3CDTF">2016-06-02T06:54:51Z</dcterms:created>
  <dcterms:modified xsi:type="dcterms:W3CDTF">2019-07-15T09:06:42Z</dcterms:modified>
</cp:coreProperties>
</file>